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7" autoAdjust="0"/>
    <p:restoredTop sz="94660"/>
  </p:normalViewPr>
  <p:slideViewPr>
    <p:cSldViewPr snapToGrid="0">
      <p:cViewPr>
        <p:scale>
          <a:sx n="150" d="100"/>
          <a:sy n="150" d="100"/>
        </p:scale>
        <p:origin x="2000" y="3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04AAA-A86F-4CC1-B2BF-CE7B471BF353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CD753-27B2-499A-903D-5D7E8430D8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675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04AAA-A86F-4CC1-B2BF-CE7B471BF353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CD753-27B2-499A-903D-5D7E8430D8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8821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04AAA-A86F-4CC1-B2BF-CE7B471BF353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CD753-27B2-499A-903D-5D7E8430D8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891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04AAA-A86F-4CC1-B2BF-CE7B471BF353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CD753-27B2-499A-903D-5D7E8430D8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845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04AAA-A86F-4CC1-B2BF-CE7B471BF353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CD753-27B2-499A-903D-5D7E8430D8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70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04AAA-A86F-4CC1-B2BF-CE7B471BF353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CD753-27B2-499A-903D-5D7E8430D8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6976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04AAA-A86F-4CC1-B2BF-CE7B471BF353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CD753-27B2-499A-903D-5D7E8430D8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366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04AAA-A86F-4CC1-B2BF-CE7B471BF353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CD753-27B2-499A-903D-5D7E8430D8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636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04AAA-A86F-4CC1-B2BF-CE7B471BF353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CD753-27B2-499A-903D-5D7E8430D8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804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04AAA-A86F-4CC1-B2BF-CE7B471BF353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CD753-27B2-499A-903D-5D7E8430D8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317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04AAA-A86F-4CC1-B2BF-CE7B471BF353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7CD753-27B2-499A-903D-5D7E8430D8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2942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804AAA-A86F-4CC1-B2BF-CE7B471BF353}" type="datetimeFigureOut">
              <a:rPr lang="en-US" smtClean="0"/>
              <a:t>8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7CD753-27B2-499A-903D-5D7E8430D8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668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gif"/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D:\PFC process\2D_slope stability\New\New_30 deg_1g\fix40\Homo (processed)\Diss25 (processed)\sav\z Absolute scale\Cforce\Cforce.gif"/>
          <p:cNvPicPr>
            <a:picLocks noChangeAspect="1" noChangeArrowheads="1" noCrop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96071" y="2730894"/>
            <a:ext cx="7616952" cy="2809775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6096" y="5151"/>
            <a:ext cx="379456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ideo - Contact force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1980145" y="655846"/>
            <a:ext cx="47500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All cases are shown at the same force </a:t>
            </a:r>
            <a:r>
              <a:rPr lang="en-US" dirty="0" smtClean="0"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scale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980145" y="1025178"/>
            <a:ext cx="4352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he video plays on the slide show mode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007558" y="101212"/>
            <a:ext cx="40427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ase: Slope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ngle: 30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° / HR=40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40782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2" descr="D:\PFC process\2D_slope stability\New\New_30 deg_1g\fix40\Homo (processed)\Diss25 (processed)\sav\z Absolute scale\Displacement\Displacement.gif"/>
          <p:cNvPicPr>
            <a:picLocks noChangeAspect="1" noChangeArrowheads="1" noCrop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00567" y="1389054"/>
            <a:ext cx="7616952" cy="2784692"/>
          </a:xfrm>
          <a:prstGeom prst="rect">
            <a:avLst/>
          </a:prstGeom>
          <a:noFill/>
        </p:spPr>
      </p:pic>
      <p:pic>
        <p:nvPicPr>
          <p:cNvPr id="13" name="Picture 3" descr="D:\PFC process\2D_slope stability\New\New_30 deg_1g\fix40\Homo (processed)\Diss25 (processed)\sav\z Absolute scale\Displ hori\Displ hori.gif"/>
          <p:cNvPicPr>
            <a:picLocks noChangeAspect="1" noChangeArrowheads="1" noCrop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96790" y="4088921"/>
            <a:ext cx="7616952" cy="2854494"/>
          </a:xfrm>
          <a:prstGeom prst="rect">
            <a:avLst/>
          </a:prstGeom>
          <a:noFill/>
        </p:spPr>
      </p:pic>
      <p:sp>
        <p:nvSpPr>
          <p:cNvPr id="14" name="TextBox 13"/>
          <p:cNvSpPr txBox="1"/>
          <p:nvPr/>
        </p:nvSpPr>
        <p:spPr>
          <a:xfrm>
            <a:off x="933450" y="2013926"/>
            <a:ext cx="2274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dirty="0" smtClean="0">
                <a:solidFill>
                  <a:prstClr val="black"/>
                </a:solidFill>
                <a:latin typeface="Arial" charset="0"/>
              </a:rPr>
              <a:t>Global </a:t>
            </a:r>
            <a:r>
              <a:rPr lang="en-US" dirty="0" smtClean="0">
                <a:solidFill>
                  <a:prstClr val="black"/>
                </a:solidFill>
                <a:latin typeface="Arial" charset="0"/>
              </a:rPr>
              <a:t>displacement</a:t>
            </a:r>
            <a:endParaRPr lang="en-US" dirty="0">
              <a:solidFill>
                <a:prstClr val="black"/>
              </a:solidFill>
              <a:latin typeface="Arial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933450" y="4631103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dirty="0" smtClean="0">
                <a:solidFill>
                  <a:prstClr val="black"/>
                </a:solidFill>
                <a:latin typeface="Arial" charset="0"/>
              </a:rPr>
              <a:t>Horizontal displacement</a:t>
            </a:r>
            <a:endParaRPr lang="en-US" dirty="0">
              <a:solidFill>
                <a:prstClr val="black"/>
              </a:solidFill>
              <a:latin typeface="Arial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350" y="6350"/>
            <a:ext cx="481086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ideo - Grain displacement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1740114" y="587747"/>
            <a:ext cx="58756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All cases shown at the same displacement vector </a:t>
            </a:r>
            <a:r>
              <a:rPr lang="en-US" dirty="0" smtClean="0">
                <a:latin typeface="Arial" panose="020B0604020202020204" pitchFamily="34" charset="0"/>
                <a:ea typeface="Batang" panose="02030600000101010101" pitchFamily="18" charset="-127"/>
                <a:cs typeface="Arial" panose="020B0604020202020204" pitchFamily="34" charset="0"/>
              </a:rPr>
              <a:t>scale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740114" y="920232"/>
            <a:ext cx="4352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he video plays on the slide show mode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007558" y="101212"/>
            <a:ext cx="40427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ase: Slope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ngle: 30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° / HR=40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31751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</TotalTime>
  <Words>70</Words>
  <Application>Microsoft Office PowerPoint</Application>
  <PresentationFormat>On-screen Show (4:3)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Batang</vt:lpstr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TAM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, Minsu</dc:creator>
  <cp:lastModifiedBy>Cha, Minsu</cp:lastModifiedBy>
  <cp:revision>13</cp:revision>
  <dcterms:created xsi:type="dcterms:W3CDTF">2019-08-27T17:03:21Z</dcterms:created>
  <dcterms:modified xsi:type="dcterms:W3CDTF">2019-08-27T17:38:54Z</dcterms:modified>
</cp:coreProperties>
</file>